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5.wmf" ContentType="image/x-wmf"/>
  <Override PartName="/ppt/media/image6.png" ContentType="image/png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EB8D4-9435-4DD4-9D29-2EE8026A77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C9A4F-5483-4871-93A0-D92E5206B9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9C61C-D55A-4D72-A13A-ECF9293AFCC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1EC50-D709-4897-B208-F5A3AEEE67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D3E12-247A-4DA9-BC04-AFA506B1B5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C71AF-1CEB-4923-B317-FE0355E2D8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94172-929E-4EB7-8984-C8408E294A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8220F-11C8-49E7-9CE6-65F37E84BE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5446D-1169-4240-8C07-D116C1229A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F5DB2-48C1-4120-9E36-6E86C8A2DD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B684F-AEE4-4E83-90BC-A8F4FDD906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D3BB5-218A-4E0D-BFAC-77CEA841A5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7F7599-D578-41C9-9257-653435E45D1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package" Target="../embeddings/oleObject2.xlsx"/><Relationship Id="rId5" Type="http://schemas.openxmlformats.org/officeDocument/2006/relationships/image" Target="../media/image3.wmf"/><Relationship Id="rId6" Type="http://schemas.openxmlformats.org/officeDocument/2006/relationships/image" Target="../media/image4.png"/><Relationship Id="rId7" Type="http://schemas.openxmlformats.org/officeDocument/2006/relationships/package" Target="../embeddings/oleObject3.xlsx"/><Relationship Id="rId8" Type="http://schemas.openxmlformats.org/officeDocument/2006/relationships/image" Target="../media/image5.wmf"/><Relationship Id="rId9" Type="http://schemas.openxmlformats.org/officeDocument/2006/relationships/image" Target="../media/image6.png"/><Relationship Id="rId10" Type="http://schemas.openxmlformats.org/officeDocument/2006/relationships/package" Target="../embeddings/oleObject4.xlsx"/><Relationship Id="rId11" Type="http://schemas.openxmlformats.org/officeDocument/2006/relationships/image" Target="../media/image7.wmf"/><Relationship Id="rId1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830920" y="826920"/>
            <a:ext cx="3313080" cy="2387520"/>
            <a:chOff x="5830920" y="826920"/>
            <a:chExt cx="3313080" cy="2387520"/>
          </a:xfrm>
        </p:grpSpPr>
        <p:graphicFrame>
          <p:nvGraphicFramePr>
            <p:cNvPr id="42" name=""/>
            <p:cNvGraphicFramePr/>
            <p:nvPr/>
          </p:nvGraphicFramePr>
          <p:xfrm>
            <a:off x="6269040" y="826920"/>
            <a:ext cx="2874960" cy="15829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6269040" y="826920"/>
                      <a:ext cx="2874960" cy="1582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 rot="16200000">
              <a:off x="6445080" y="2584800"/>
              <a:ext cx="95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h-TGFB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7494480" y="2412360"/>
              <a:ext cx="605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8244720" y="2461680"/>
              <a:ext cx="70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129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5684400" y="1347120"/>
              <a:ext cx="60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g/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µ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 rot="16200000">
            <a:off x="423360" y="1457640"/>
            <a:ext cx="8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1" lang="es-ES" sz="1400" spc="-1" strike="noStrike" u="sng">
                <a:solidFill>
                  <a:srgbClr val="000000"/>
                </a:solidFill>
                <a:uFillTx/>
                <a:latin typeface="Arial"/>
              </a:rPr>
              <a:t>A54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350640" y="1855800"/>
            <a:ext cx="1625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A549 TGFBI v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1007640" y="1528920"/>
            <a:ext cx="97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1" lang="es-ES" sz="1400" spc="-1" strike="noStrike" u="sng">
                <a:solidFill>
                  <a:srgbClr val="000000"/>
                </a:solidFill>
                <a:uFillTx/>
                <a:latin typeface="Arial"/>
              </a:rPr>
              <a:t>H12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865440" y="2020320"/>
            <a:ext cx="195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H1299 TGFBI v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-451080" y="2032200"/>
            <a:ext cx="19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7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1" lang="es-ES" sz="1400" spc="-1" strike="noStrike" u="sng">
                <a:solidFill>
                  <a:srgbClr val="000000"/>
                </a:solidFill>
                <a:uFillTx/>
                <a:latin typeface="Arial"/>
              </a:rPr>
              <a:t>rh-TGFBI (10 ng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3"/>
          <a:srcRect l="48381" t="24905" r="3760" b="55115"/>
          <a:stretch/>
        </p:blipFill>
        <p:spPr>
          <a:xfrm>
            <a:off x="455760" y="880920"/>
            <a:ext cx="1644480" cy="3430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54" name=""/>
          <p:cNvSpPr/>
          <p:nvPr/>
        </p:nvSpPr>
        <p:spPr>
          <a:xfrm>
            <a:off x="1195560" y="3656160"/>
            <a:ext cx="16048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3120" rIns="33120" tIns="16560" bIns="1656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223920"/>
                <a:tab algn="l" pos="447840"/>
                <a:tab algn="l" pos="671400"/>
                <a:tab algn="l" pos="895320"/>
                <a:tab algn="l" pos="1119240"/>
                <a:tab algn="l" pos="1343160"/>
                <a:tab algn="l" pos="1566720"/>
                <a:tab algn="l" pos="1790640"/>
                <a:tab algn="l" pos="2014560"/>
                <a:tab algn="l" pos="2238480"/>
                <a:tab algn="l" pos="2462040"/>
                <a:tab algn="l" pos="2685960"/>
                <a:tab algn="l" pos="2909880"/>
                <a:tab algn="l" pos="3133800"/>
                <a:tab algn="l" pos="3357720"/>
                <a:tab algn="l" pos="3581280"/>
                <a:tab algn="l" pos="3805200"/>
                <a:tab algn="l" pos="4029120"/>
                <a:tab algn="l" pos="4253040"/>
                <a:tab algn="l" pos="44766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A549-shTGFB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7760" y="4190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181120" y="0"/>
            <a:ext cx="3962520" cy="542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igoyen et al. Additional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"/>
          <p:cNvGrpSpPr/>
          <p:nvPr/>
        </p:nvGrpSpPr>
        <p:grpSpPr>
          <a:xfrm>
            <a:off x="371880" y="3979800"/>
            <a:ext cx="2984040" cy="3014280"/>
            <a:chOff x="371880" y="3979800"/>
            <a:chExt cx="2984040" cy="3014280"/>
          </a:xfrm>
        </p:grpSpPr>
        <p:grpSp>
          <p:nvGrpSpPr>
            <p:cNvPr id="58" name=""/>
            <p:cNvGrpSpPr/>
            <p:nvPr/>
          </p:nvGrpSpPr>
          <p:grpSpPr>
            <a:xfrm>
              <a:off x="371880" y="3979800"/>
              <a:ext cx="2984040" cy="2829600"/>
              <a:chOff x="371880" y="3979800"/>
              <a:chExt cx="2984040" cy="2829600"/>
            </a:xfrm>
          </p:grpSpPr>
          <p:graphicFrame>
            <p:nvGraphicFramePr>
              <p:cNvPr id="59" name=""/>
              <p:cNvGraphicFramePr/>
              <p:nvPr/>
            </p:nvGraphicFramePr>
            <p:xfrm>
              <a:off x="890640" y="4751280"/>
              <a:ext cx="2465280" cy="1643040"/>
            </p:xfrm>
            <a:graphic>
              <a:graphicData uri="http://schemas.openxmlformats.org/presentationml/2006/ole">
                <p:oleObj progId="Excel.Sheet.12" r:id="rId4" spid="">
                  <p:embed/>
                  <p:pic>
                    <p:nvPicPr>
                      <p:cNvPr id="60" name="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890640" y="4751280"/>
                        <a:ext cx="2465280" cy="1643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61" name=""/>
              <p:cNvGrpSpPr/>
              <p:nvPr/>
            </p:nvGrpSpPr>
            <p:grpSpPr>
              <a:xfrm>
                <a:off x="1084320" y="3979800"/>
                <a:ext cx="1790280" cy="1107720"/>
                <a:chOff x="1084320" y="3979800"/>
                <a:chExt cx="1790280" cy="1107720"/>
              </a:xfrm>
            </p:grpSpPr>
            <p:pic>
              <p:nvPicPr>
                <p:cNvPr id="62" name="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1106280" y="3979800"/>
                  <a:ext cx="1768320" cy="40464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63" name=""/>
                <p:cNvSpPr/>
                <p:nvPr/>
              </p:nvSpPr>
              <p:spPr>
                <a:xfrm>
                  <a:off x="1084320" y="4368600"/>
                  <a:ext cx="3088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1350000" y="436860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01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1648440" y="436860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0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1946880" y="436860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03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2239200" y="436860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0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 rot="16200000">
                  <a:off x="2290680" y="4509360"/>
                  <a:ext cx="8492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Empty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1560600" y="4635360"/>
                  <a:ext cx="8514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Sh-RNA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1441080" y="4630680"/>
                  <a:ext cx="10857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1" name=""/>
              <p:cNvSpPr/>
              <p:nvPr/>
            </p:nvSpPr>
            <p:spPr>
              <a:xfrm>
                <a:off x="371880" y="4660920"/>
                <a:ext cx="577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71880" y="4933800"/>
                <a:ext cx="577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6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71880" y="5207040"/>
                <a:ext cx="577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70520" y="54990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70520" y="575928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687240" y="60516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951120" y="6184800"/>
                <a:ext cx="308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299600" y="618480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661760" y="618480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049120" y="618480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442600" y="618480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637280" y="6502320"/>
                <a:ext cx="851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Sh-RN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422360" y="6497640"/>
                <a:ext cx="131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"/>
            <p:cNvSpPr/>
            <p:nvPr/>
          </p:nvSpPr>
          <p:spPr>
            <a:xfrm rot="16200000">
              <a:off x="2557800" y="6415920"/>
              <a:ext cx="849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"/>
          <p:cNvSpPr/>
          <p:nvPr/>
        </p:nvSpPr>
        <p:spPr>
          <a:xfrm>
            <a:off x="93600" y="37893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4337280" y="4148280"/>
            <a:ext cx="3298320" cy="2864880"/>
            <a:chOff x="4337280" y="4148280"/>
            <a:chExt cx="3298320" cy="2864880"/>
          </a:xfrm>
        </p:grpSpPr>
        <p:sp>
          <p:nvSpPr>
            <p:cNvPr id="87" name=""/>
            <p:cNvSpPr/>
            <p:nvPr/>
          </p:nvSpPr>
          <p:spPr>
            <a:xfrm rot="16200000">
              <a:off x="6755040" y="6435000"/>
              <a:ext cx="849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"/>
            <p:cNvGrpSpPr/>
            <p:nvPr/>
          </p:nvGrpSpPr>
          <p:grpSpPr>
            <a:xfrm>
              <a:off x="4337280" y="4148280"/>
              <a:ext cx="3298320" cy="2323080"/>
              <a:chOff x="4337280" y="4148280"/>
              <a:chExt cx="3298320" cy="2323080"/>
            </a:xfrm>
          </p:grpSpPr>
          <p:graphicFrame>
            <p:nvGraphicFramePr>
              <p:cNvPr id="89" name=""/>
              <p:cNvGraphicFramePr/>
              <p:nvPr/>
            </p:nvGraphicFramePr>
            <p:xfrm>
              <a:off x="4740120" y="4613400"/>
              <a:ext cx="2895480" cy="1676160"/>
            </p:xfrm>
            <a:graphic>
              <a:graphicData uri="http://schemas.openxmlformats.org/presentationml/2006/ole">
                <p:oleObj progId="Excel.Sheet.12" r:id="rId7" spid="">
                  <p:embed/>
                  <p:pic>
                    <p:nvPicPr>
                      <p:cNvPr id="90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4740120" y="4613400"/>
                        <a:ext cx="2895480" cy="16761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91" name=""/>
              <p:cNvSpPr/>
              <p:nvPr/>
            </p:nvSpPr>
            <p:spPr>
              <a:xfrm>
                <a:off x="4337280" y="4614840"/>
                <a:ext cx="577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435920" y="48816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435920" y="514836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435920" y="543384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435920" y="570708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633560" y="598644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996080" y="6164280"/>
                <a:ext cx="308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5636160" y="616428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: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6302880" y="616428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: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0" name=""/>
              <p:cNvGrpSpPr/>
              <p:nvPr/>
            </p:nvGrpSpPr>
            <p:grpSpPr>
              <a:xfrm>
                <a:off x="5808600" y="4148280"/>
                <a:ext cx="1500120" cy="1080720"/>
                <a:chOff x="5808600" y="4148280"/>
                <a:chExt cx="1500120" cy="1080720"/>
              </a:xfrm>
            </p:grpSpPr>
            <p:pic>
              <p:nvPicPr>
                <p:cNvPr id="101" name="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5808600" y="4148280"/>
                  <a:ext cx="1500120" cy="28584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02" name=""/>
                <p:cNvSpPr/>
                <p:nvPr/>
              </p:nvSpPr>
              <p:spPr>
                <a:xfrm>
                  <a:off x="5841720" y="4380120"/>
                  <a:ext cx="3088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6139080" y="4380120"/>
                  <a:ext cx="4381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1: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6526440" y="4380120"/>
                  <a:ext cx="4381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1:3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 rot="16200000">
                  <a:off x="6686640" y="4650840"/>
                  <a:ext cx="8492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Empty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06" name=""/>
          <p:cNvSpPr/>
          <p:nvPr/>
        </p:nvSpPr>
        <p:spPr>
          <a:xfrm>
            <a:off x="5754600" y="3727440"/>
            <a:ext cx="16048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3120" rIns="33120" tIns="16560" bIns="1656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223920"/>
                <a:tab algn="l" pos="447840"/>
                <a:tab algn="l" pos="671400"/>
                <a:tab algn="l" pos="895320"/>
                <a:tab algn="l" pos="1119240"/>
                <a:tab algn="l" pos="1343160"/>
                <a:tab algn="l" pos="1566720"/>
                <a:tab algn="l" pos="1790640"/>
                <a:tab algn="l" pos="2014560"/>
                <a:tab algn="l" pos="2238480"/>
                <a:tab algn="l" pos="2462040"/>
                <a:tab algn="l" pos="2685960"/>
                <a:tab algn="l" pos="2909880"/>
                <a:tab algn="l" pos="3133800"/>
                <a:tab algn="l" pos="3357720"/>
                <a:tab algn="l" pos="3581280"/>
                <a:tab algn="l" pos="3805200"/>
                <a:tab algn="l" pos="4029120"/>
                <a:tab algn="l" pos="4253040"/>
                <a:tab algn="l" pos="44766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H1299-veTGFB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"/>
          <p:cNvGrpSpPr/>
          <p:nvPr/>
        </p:nvGrpSpPr>
        <p:grpSpPr>
          <a:xfrm>
            <a:off x="2203560" y="722160"/>
            <a:ext cx="3673440" cy="3051000"/>
            <a:chOff x="2203560" y="722160"/>
            <a:chExt cx="3673440" cy="3051000"/>
          </a:xfrm>
        </p:grpSpPr>
        <p:graphicFrame>
          <p:nvGraphicFramePr>
            <p:cNvPr id="108" name=""/>
            <p:cNvGraphicFramePr/>
            <p:nvPr/>
          </p:nvGraphicFramePr>
          <p:xfrm>
            <a:off x="2567160" y="838080"/>
            <a:ext cx="3309840" cy="1546200"/>
          </p:xfrm>
          <a:graphic>
            <a:graphicData uri="http://schemas.openxmlformats.org/presentationml/2006/ole">
              <p:oleObj progId="Excel.Sheet.12" r:id="rId10" spid="">
                <p:embed/>
                <p:pic>
                  <p:nvPicPr>
                    <p:cNvPr id="109" name="" descr=""/>
                    <p:cNvPicPr/>
                    <p:nvPr/>
                  </p:nvPicPr>
                  <p:blipFill>
                    <a:blip r:embed="rId11"/>
                    <a:stretch/>
                  </p:blipFill>
                  <p:spPr>
                    <a:xfrm>
                      <a:off x="2567160" y="838080"/>
                      <a:ext cx="3309840" cy="1546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0" name=""/>
            <p:cNvSpPr/>
            <p:nvPr/>
          </p:nvSpPr>
          <p:spPr>
            <a:xfrm>
              <a:off x="2452320" y="72216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452320" y="106488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452320" y="141444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452320" y="177624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550960" y="21254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6200000">
              <a:off x="2633400" y="2562120"/>
              <a:ext cx="95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h-TGFB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16200000">
              <a:off x="3390840" y="2390400"/>
              <a:ext cx="605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rot="16200000">
              <a:off x="3560400" y="2808360"/>
              <a:ext cx="144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549 TGFBI-v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rot="16200000">
              <a:off x="4534920" y="2439360"/>
              <a:ext cx="70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129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rot="16200000">
              <a:off x="4698720" y="2846520"/>
              <a:ext cx="1546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1299 TGFBI-v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16200000">
              <a:off x="2057040" y="1438920"/>
              <a:ext cx="60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g/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µ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"/>
          <p:cNvSpPr/>
          <p:nvPr/>
        </p:nvSpPr>
        <p:spPr>
          <a:xfrm>
            <a:off x="6099480" y="76212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248160" y="1015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099480" y="129528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248160" y="1574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099480" y="186696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248160" y="21398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rot="16200000">
            <a:off x="-934560" y="5365080"/>
            <a:ext cx="245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bitrary absorbance uni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rot="16200000">
            <a:off x="3038760" y="5281200"/>
            <a:ext cx="245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bitrary absorbance uni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647800" y="4190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068880" y="4176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168800" y="3816360"/>
            <a:ext cx="349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30T15:04:30Z</dcterms:created>
  <dc:creator>Centro de Tecnología Informática</dc:creator>
  <dc:description/>
  <dc:language>en-US</dc:language>
  <cp:lastModifiedBy>Centro de Tecnología Informática</cp:lastModifiedBy>
  <dcterms:modified xsi:type="dcterms:W3CDTF">2010-05-19T10:44:35Z</dcterms:modified>
  <cp:revision>5</cp:revision>
  <dc:subject/>
  <dc:title>Supplementary figure 2:TGFBI quantification</dc:title>
</cp:coreProperties>
</file>